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722" y="-2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7203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5401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777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7003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9009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2583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9468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8449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9089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5462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2510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885D26-5F41-48BE-B0DE-36C4EF7FCBFA}" type="datetimeFigureOut">
              <a:rPr lang="en-GB" smtClean="0"/>
              <a:pPr/>
              <a:t>30/07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5B3C0-7883-4EF5-9AE7-9FC457A00C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3497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w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Group 81"/>
          <p:cNvGrpSpPr/>
          <p:nvPr/>
        </p:nvGrpSpPr>
        <p:grpSpPr>
          <a:xfrm>
            <a:off x="-50800" y="916913"/>
            <a:ext cx="9312275" cy="4837488"/>
            <a:chOff x="-50800" y="916913"/>
            <a:chExt cx="9312275" cy="4837488"/>
          </a:xfrm>
        </p:grpSpPr>
        <p:graphicFrame>
          <p:nvGraphicFramePr>
            <p:cNvPr id="30722" name="Object 2"/>
            <p:cNvGraphicFramePr>
              <a:graphicFrameLocks noChangeAspect="1"/>
            </p:cNvGraphicFramePr>
            <p:nvPr/>
          </p:nvGraphicFramePr>
          <p:xfrm>
            <a:off x="-50800" y="955675"/>
            <a:ext cx="2606675" cy="19923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22" name="Prism Project" r:id="rId3" imgW="3259836" imgH="2490216" progId="Prism.Document">
                    <p:embed/>
                  </p:oleObj>
                </mc:Choice>
                <mc:Fallback>
                  <p:oleObj name="Prism Project" r:id="rId3" imgW="3259836" imgH="2490216" progId="Prism.Document">
                    <p:embed/>
                    <p:pic>
                      <p:nvPicPr>
                        <p:cNvPr id="0" name="Picture 2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-50800" y="955675"/>
                          <a:ext cx="2606675" cy="1992313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724" name="Object 4"/>
            <p:cNvGraphicFramePr>
              <a:graphicFrameLocks noChangeAspect="1"/>
            </p:cNvGraphicFramePr>
            <p:nvPr/>
          </p:nvGraphicFramePr>
          <p:xfrm>
            <a:off x="4519909" y="3475682"/>
            <a:ext cx="2490788" cy="2003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23" name="Prism Project" r:id="rId5" imgW="3113532" imgH="2508504" progId="Prism.Document">
                    <p:embed/>
                  </p:oleObj>
                </mc:Choice>
                <mc:Fallback>
                  <p:oleObj name="Prism Project" r:id="rId5" imgW="3113532" imgH="2508504" progId="Prism.Document">
                    <p:embed/>
                    <p:pic>
                      <p:nvPicPr>
                        <p:cNvPr id="0" name="Picture 2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519909" y="3475682"/>
                          <a:ext cx="2490788" cy="20034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725" name="Object 5"/>
            <p:cNvGraphicFramePr>
              <a:graphicFrameLocks noChangeAspect="1"/>
            </p:cNvGraphicFramePr>
            <p:nvPr/>
          </p:nvGraphicFramePr>
          <p:xfrm>
            <a:off x="4451811" y="916913"/>
            <a:ext cx="2549525" cy="2012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24" name="Prism Project" r:id="rId7" imgW="3186684" imgH="2517648" progId="Prism.Document">
                    <p:embed/>
                  </p:oleObj>
                </mc:Choice>
                <mc:Fallback>
                  <p:oleObj name="Prism Project" r:id="rId7" imgW="3186684" imgH="2517648" progId="Prism.Document">
                    <p:embed/>
                    <p:pic>
                      <p:nvPicPr>
                        <p:cNvPr id="0" name="Picture 2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451811" y="916913"/>
                          <a:ext cx="2549525" cy="20129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726" name="Object 6"/>
            <p:cNvGraphicFramePr>
              <a:graphicFrameLocks noChangeAspect="1"/>
            </p:cNvGraphicFramePr>
            <p:nvPr/>
          </p:nvGraphicFramePr>
          <p:xfrm>
            <a:off x="2228652" y="974774"/>
            <a:ext cx="2490788" cy="19542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25" name="Prism Project" r:id="rId9" imgW="3113532" imgH="2444496" progId="Prism.Document">
                    <p:embed/>
                  </p:oleObj>
                </mc:Choice>
                <mc:Fallback>
                  <p:oleObj name="Prism Project" r:id="rId9" imgW="3113532" imgH="2444496" progId="Prism.Document">
                    <p:embed/>
                    <p:pic>
                      <p:nvPicPr>
                        <p:cNvPr id="0" name="Picture 29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0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228652" y="974774"/>
                          <a:ext cx="2490788" cy="195421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727" name="Object 7"/>
            <p:cNvGraphicFramePr>
              <a:graphicFrameLocks noChangeAspect="1"/>
            </p:cNvGraphicFramePr>
            <p:nvPr/>
          </p:nvGraphicFramePr>
          <p:xfrm>
            <a:off x="-40326" y="3497584"/>
            <a:ext cx="2606675" cy="1982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26" name="Prism Project" r:id="rId11" imgW="3259836" imgH="2481072" progId="Prism.Document">
                    <p:embed/>
                  </p:oleObj>
                </mc:Choice>
                <mc:Fallback>
                  <p:oleObj name="Prism Project" r:id="rId11" imgW="3259836" imgH="2481072" progId="Prism.Document">
                    <p:embed/>
                    <p:pic>
                      <p:nvPicPr>
                        <p:cNvPr id="0" name="Picture 30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-40326" y="3497584"/>
                          <a:ext cx="2606675" cy="19827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728" name="Object 8"/>
            <p:cNvGraphicFramePr>
              <a:graphicFrameLocks noChangeAspect="1"/>
            </p:cNvGraphicFramePr>
            <p:nvPr/>
          </p:nvGraphicFramePr>
          <p:xfrm>
            <a:off x="2176099" y="3520789"/>
            <a:ext cx="2549525" cy="19573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27" name="Prism Project" r:id="rId13" imgW="3186684" imgH="2444496" progId="Prism.Document">
                    <p:embed/>
                  </p:oleObj>
                </mc:Choice>
                <mc:Fallback>
                  <p:oleObj name="Prism Project" r:id="rId13" imgW="3186684" imgH="2444496" progId="Prism.Document">
                    <p:embed/>
                    <p:pic>
                      <p:nvPicPr>
                        <p:cNvPr id="0" name="Picture 3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76099" y="3520789"/>
                          <a:ext cx="2549525" cy="19573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TextBox 13"/>
            <p:cNvSpPr txBox="1"/>
            <p:nvPr/>
          </p:nvSpPr>
          <p:spPr>
            <a:xfrm>
              <a:off x="627674" y="2735020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ntac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170424" y="2746660"/>
              <a:ext cx="4523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CTL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514258" y="2746660"/>
              <a:ext cx="8899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GLPG0492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1281752" y="2967814"/>
              <a:ext cx="7854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/>
            <p:cNvSpPr txBox="1"/>
            <p:nvPr/>
          </p:nvSpPr>
          <p:spPr>
            <a:xfrm>
              <a:off x="1152791" y="2944373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mmobilized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799247" y="2735020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ntac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341997" y="2746660"/>
              <a:ext cx="4523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CTL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685831" y="2746660"/>
              <a:ext cx="8899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GLPG0492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5" name="Straight Connector 24"/>
            <p:cNvCxnSpPr/>
            <p:nvPr/>
          </p:nvCxnSpPr>
          <p:spPr>
            <a:xfrm>
              <a:off x="3453325" y="2967814"/>
              <a:ext cx="7854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3324364" y="2944373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mmobilized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058655" y="2709319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ntac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601405" y="2720959"/>
              <a:ext cx="4523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CTL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945239" y="2720959"/>
              <a:ext cx="8899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GLPG0492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9" name="Straight Connector 38"/>
            <p:cNvCxnSpPr/>
            <p:nvPr/>
          </p:nvCxnSpPr>
          <p:spPr>
            <a:xfrm>
              <a:off x="5712733" y="2942113"/>
              <a:ext cx="7854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/>
            <p:cNvSpPr txBox="1"/>
            <p:nvPr/>
          </p:nvSpPr>
          <p:spPr>
            <a:xfrm>
              <a:off x="5583772" y="2918672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mmobilized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075596" y="5263325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ntac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5618346" y="5274965"/>
              <a:ext cx="4523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CTL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962180" y="5274965"/>
              <a:ext cx="8899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GLPG0492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4" name="Straight Connector 33"/>
            <p:cNvCxnSpPr/>
            <p:nvPr/>
          </p:nvCxnSpPr>
          <p:spPr>
            <a:xfrm>
              <a:off x="5729674" y="5496119"/>
              <a:ext cx="7854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5600713" y="5472678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mmobilized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628456" y="5257544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ntac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171206" y="5269184"/>
              <a:ext cx="4523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CTL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515040" y="5269184"/>
              <a:ext cx="8899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GLPG0492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2" name="Straight Connector 51"/>
            <p:cNvCxnSpPr/>
            <p:nvPr/>
          </p:nvCxnSpPr>
          <p:spPr>
            <a:xfrm>
              <a:off x="1282534" y="5490338"/>
              <a:ext cx="7854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1153573" y="5466897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mmobilized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715937" y="5268049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ntac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258687" y="5279689"/>
              <a:ext cx="4523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CTL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602521" y="5279689"/>
              <a:ext cx="8899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GLPG0492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7" name="Straight Connector 46"/>
            <p:cNvCxnSpPr/>
            <p:nvPr/>
          </p:nvCxnSpPr>
          <p:spPr>
            <a:xfrm>
              <a:off x="3370015" y="5500843"/>
              <a:ext cx="7854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3241054" y="5477402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mmobilized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694409" y="1252570"/>
              <a:ext cx="3257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153849" y="1094361"/>
              <a:ext cx="3257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*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6193540" y="3893007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905877" y="3762316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741024" y="3731759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902285" y="1232514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2" name="Group 61"/>
            <p:cNvGrpSpPr/>
            <p:nvPr/>
          </p:nvGrpSpPr>
          <p:grpSpPr>
            <a:xfrm>
              <a:off x="3025422" y="3734313"/>
              <a:ext cx="558625" cy="253916"/>
              <a:chOff x="822960" y="832104"/>
              <a:chExt cx="649224" cy="253916"/>
            </a:xfrm>
          </p:grpSpPr>
          <p:cxnSp>
            <p:nvCxnSpPr>
              <p:cNvPr id="63" name="Straight Connector 62"/>
              <p:cNvCxnSpPr/>
              <p:nvPr/>
            </p:nvCxnSpPr>
            <p:spPr>
              <a:xfrm>
                <a:off x="822960" y="1060704"/>
                <a:ext cx="6492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Box 63"/>
              <p:cNvSpPr txBox="1"/>
              <p:nvPr/>
            </p:nvSpPr>
            <p:spPr>
              <a:xfrm>
                <a:off x="969264" y="832104"/>
                <a:ext cx="302177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#</a:t>
                </a:r>
                <a:endParaRPr lang="en-US" sz="105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aphicFrame>
          <p:nvGraphicFramePr>
            <p:cNvPr id="30729" name="Object 9"/>
            <p:cNvGraphicFramePr>
              <a:graphicFrameLocks noChangeAspect="1"/>
            </p:cNvGraphicFramePr>
            <p:nvPr/>
          </p:nvGraphicFramePr>
          <p:xfrm>
            <a:off x="6652830" y="944123"/>
            <a:ext cx="2606675" cy="1982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28" name="Prism Project" r:id="rId15" imgW="3259836" imgH="2481072" progId="Prism.Document">
                    <p:embed/>
                  </p:oleObj>
                </mc:Choice>
                <mc:Fallback>
                  <p:oleObj name="Prism Project" r:id="rId15" imgW="3259836" imgH="2481072" progId="Prism.Document">
                    <p:embed/>
                    <p:pic>
                      <p:nvPicPr>
                        <p:cNvPr id="0" name="Picture 3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6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652830" y="944123"/>
                          <a:ext cx="2606675" cy="19827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0730" name="Object 10"/>
            <p:cNvGraphicFramePr>
              <a:graphicFrameLocks noChangeAspect="1"/>
            </p:cNvGraphicFramePr>
            <p:nvPr/>
          </p:nvGraphicFramePr>
          <p:xfrm>
            <a:off x="6770688" y="3496153"/>
            <a:ext cx="2490787" cy="19843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29" name="Prism Project" r:id="rId17" imgW="3113532" imgH="2481072" progId="Prism.Document">
                    <p:embed/>
                  </p:oleObj>
                </mc:Choice>
                <mc:Fallback>
                  <p:oleObj name="Prism Project" r:id="rId17" imgW="3113532" imgH="2481072" progId="Prism.Document">
                    <p:embed/>
                    <p:pic>
                      <p:nvPicPr>
                        <p:cNvPr id="0" name="Picture 33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8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770688" y="3496153"/>
                          <a:ext cx="2490787" cy="198437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chemeClr val="bg2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6" name="TextBox 65"/>
            <p:cNvSpPr txBox="1"/>
            <p:nvPr/>
          </p:nvSpPr>
          <p:spPr>
            <a:xfrm>
              <a:off x="7330063" y="5263325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ntac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7872813" y="5274965"/>
              <a:ext cx="4523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CTL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8216647" y="5274965"/>
              <a:ext cx="8899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GLPG0492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9" name="Straight Connector 68"/>
            <p:cNvCxnSpPr/>
            <p:nvPr/>
          </p:nvCxnSpPr>
          <p:spPr>
            <a:xfrm>
              <a:off x="7984141" y="5496119"/>
              <a:ext cx="7854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7855180" y="5472678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mmobilized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334143" y="2709319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ntact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7876893" y="2720959"/>
              <a:ext cx="4523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CTL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8220727" y="2720959"/>
              <a:ext cx="88998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latin typeface="Arial" pitchFamily="34" charset="0"/>
                  <a:cs typeface="Arial" pitchFamily="34" charset="0"/>
                </a:rPr>
                <a:t>GLPG0492</a:t>
              </a:r>
              <a:endParaRPr lang="en-US" sz="11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5" name="Straight Connector 74"/>
            <p:cNvCxnSpPr/>
            <p:nvPr/>
          </p:nvCxnSpPr>
          <p:spPr>
            <a:xfrm>
              <a:off x="7988221" y="2942113"/>
              <a:ext cx="78544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/>
            <p:cNvSpPr txBox="1"/>
            <p:nvPr/>
          </p:nvSpPr>
          <p:spPr>
            <a:xfrm>
              <a:off x="7859260" y="2918672"/>
              <a:ext cx="10021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mmobilized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77" name="Group 76"/>
            <p:cNvGrpSpPr/>
            <p:nvPr/>
          </p:nvGrpSpPr>
          <p:grpSpPr>
            <a:xfrm>
              <a:off x="7585759" y="3720858"/>
              <a:ext cx="488026" cy="253917"/>
              <a:chOff x="822960" y="894397"/>
              <a:chExt cx="649224" cy="190493"/>
            </a:xfrm>
          </p:grpSpPr>
          <p:cxnSp>
            <p:nvCxnSpPr>
              <p:cNvPr id="78" name="Straight Connector 77"/>
              <p:cNvCxnSpPr/>
              <p:nvPr/>
            </p:nvCxnSpPr>
            <p:spPr>
              <a:xfrm>
                <a:off x="822960" y="1060704"/>
                <a:ext cx="64922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9" name="TextBox 78"/>
              <p:cNvSpPr txBox="1"/>
              <p:nvPr/>
            </p:nvSpPr>
            <p:spPr>
              <a:xfrm>
                <a:off x="969264" y="894397"/>
                <a:ext cx="345890" cy="1904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 smtClean="0">
                    <a:latin typeface="Arial" pitchFamily="34" charset="0"/>
                    <a:cs typeface="Arial" pitchFamily="34" charset="0"/>
                  </a:rPr>
                  <a:t>#</a:t>
                </a:r>
                <a:endParaRPr lang="en-US" sz="105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81" name="TextBox 80"/>
            <p:cNvSpPr txBox="1"/>
            <p:nvPr/>
          </p:nvSpPr>
          <p:spPr>
            <a:xfrm>
              <a:off x="8443508" y="1169323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83" name="TextBox 82"/>
          <p:cNvSpPr txBox="1"/>
          <p:nvPr/>
        </p:nvSpPr>
        <p:spPr>
          <a:xfrm>
            <a:off x="79021" y="6477379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itchFamily="34" charset="0"/>
                <a:cs typeface="Arial" pitchFamily="34" charset="0"/>
              </a:rPr>
              <a:t>Figure 4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71213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</TotalTime>
  <Words>43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ilippe Clement-Lacroix</dc:creator>
  <cp:lastModifiedBy>Philippe Clement-Lacroix</cp:lastModifiedBy>
  <cp:revision>35</cp:revision>
  <cp:lastPrinted>2014-07-28T15:00:35Z</cp:lastPrinted>
  <dcterms:created xsi:type="dcterms:W3CDTF">2014-01-01T12:48:42Z</dcterms:created>
  <dcterms:modified xsi:type="dcterms:W3CDTF">2014-07-30T20:04:11Z</dcterms:modified>
</cp:coreProperties>
</file>